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3" r:id="rId2"/>
  </p:sldIdLst>
  <p:sldSz cx="7561263" cy="10693400"/>
  <p:notesSz cx="6797675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Aude" initials="A" lastIdx="2" clrIdx="0"/>
  <p:cmAuthor id="1" name="SusanE Ford" initials="SF" lastIdx="8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708" y="2808"/>
      </p:cViewPr>
      <p:guideLst>
        <p:guide orient="horz" pos="3368"/>
        <p:guide pos="238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8E823F-BA4A-4C75-95CB-808A8FA2BAA7}" type="datetimeFigureOut">
              <a:rPr lang="fr-FR" smtClean="0"/>
              <a:t>28/02/2013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082800" y="744538"/>
            <a:ext cx="263207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3E3E0EB-2843-4735-BA5D-517C0F1E443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154931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67095" y="3321886"/>
            <a:ext cx="6427074" cy="2292150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134190" y="6059593"/>
            <a:ext cx="5292884" cy="2732758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A7593-45E0-4DF4-9CE3-3C21281592EA}" type="datetimeFigureOut">
              <a:rPr lang="fr-FR" smtClean="0"/>
              <a:t>28/02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7C01D0-9FE6-47FF-9168-E573D4DE1E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966005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A7593-45E0-4DF4-9CE3-3C21281592EA}" type="datetimeFigureOut">
              <a:rPr lang="fr-FR" smtClean="0"/>
              <a:t>28/02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7C01D0-9FE6-47FF-9168-E573D4DE1E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092222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5481916" y="428232"/>
            <a:ext cx="1701284" cy="912404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78063" y="428232"/>
            <a:ext cx="4977831" cy="912404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A7593-45E0-4DF4-9CE3-3C21281592EA}" type="datetimeFigureOut">
              <a:rPr lang="fr-FR" smtClean="0"/>
              <a:t>28/02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7C01D0-9FE6-47FF-9168-E573D4DE1E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629653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A7593-45E0-4DF4-9CE3-3C21281592EA}" type="datetimeFigureOut">
              <a:rPr lang="fr-FR" smtClean="0"/>
              <a:t>28/02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7C01D0-9FE6-47FF-9168-E573D4DE1E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729059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97287" y="6871500"/>
            <a:ext cx="6427074" cy="2123828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97287" y="4532320"/>
            <a:ext cx="6427074" cy="233918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A7593-45E0-4DF4-9CE3-3C21281592EA}" type="datetimeFigureOut">
              <a:rPr lang="fr-FR" smtClean="0"/>
              <a:t>28/02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7C01D0-9FE6-47FF-9168-E573D4DE1E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21351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78063" y="2495127"/>
            <a:ext cx="3339558" cy="705715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843642" y="2495127"/>
            <a:ext cx="3339558" cy="705715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A7593-45E0-4DF4-9CE3-3C21281592EA}" type="datetimeFigureOut">
              <a:rPr lang="fr-FR" smtClean="0"/>
              <a:t>28/02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7C01D0-9FE6-47FF-9168-E573D4DE1E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913919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78063" y="2393639"/>
            <a:ext cx="3340871" cy="99755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78063" y="3391194"/>
            <a:ext cx="3340871" cy="616108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841017" y="2393639"/>
            <a:ext cx="3342183" cy="99755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841017" y="3391194"/>
            <a:ext cx="3342183" cy="616108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A7593-45E0-4DF4-9CE3-3C21281592EA}" type="datetimeFigureOut">
              <a:rPr lang="fr-FR" smtClean="0"/>
              <a:t>28/02/2013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7C01D0-9FE6-47FF-9168-E573D4DE1E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596029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A7593-45E0-4DF4-9CE3-3C21281592EA}" type="datetimeFigureOut">
              <a:rPr lang="fr-FR" smtClean="0"/>
              <a:t>28/02/2013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7C01D0-9FE6-47FF-9168-E573D4DE1E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450333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A7593-45E0-4DF4-9CE3-3C21281592EA}" type="datetimeFigureOut">
              <a:rPr lang="fr-FR" smtClean="0"/>
              <a:t>28/02/2013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7C01D0-9FE6-47FF-9168-E573D4DE1E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485920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78064" y="425756"/>
            <a:ext cx="2487603" cy="181193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956244" y="425756"/>
            <a:ext cx="4226956" cy="912652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78064" y="2237694"/>
            <a:ext cx="2487603" cy="731458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A7593-45E0-4DF4-9CE3-3C21281592EA}" type="datetimeFigureOut">
              <a:rPr lang="fr-FR" smtClean="0"/>
              <a:t>28/02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7C01D0-9FE6-47FF-9168-E573D4DE1E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989698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482060" y="7485380"/>
            <a:ext cx="4536758" cy="88369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482060" y="955475"/>
            <a:ext cx="4536758" cy="64160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482060" y="8369071"/>
            <a:ext cx="4536758" cy="125498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A7593-45E0-4DF4-9CE3-3C21281592EA}" type="datetimeFigureOut">
              <a:rPr lang="fr-FR" smtClean="0"/>
              <a:t>28/02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7C01D0-9FE6-47FF-9168-E573D4DE1E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102910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78063" y="428232"/>
            <a:ext cx="6805137" cy="178223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78063" y="2495127"/>
            <a:ext cx="6805137" cy="70571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78063" y="9911198"/>
            <a:ext cx="1764295" cy="5693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AA7593-45E0-4DF4-9CE3-3C21281592EA}" type="datetimeFigureOut">
              <a:rPr lang="fr-FR" smtClean="0"/>
              <a:t>28/02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583432" y="9911198"/>
            <a:ext cx="2394400" cy="5693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5418905" y="9911198"/>
            <a:ext cx="1764295" cy="5693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7C01D0-9FE6-47FF-9168-E573D4DE1E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185067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au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08994687"/>
              </p:ext>
            </p:extLst>
          </p:nvPr>
        </p:nvGraphicFramePr>
        <p:xfrm>
          <a:off x="179201" y="350905"/>
          <a:ext cx="7255446" cy="777687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979152"/>
                <a:gridCol w="883767"/>
                <a:gridCol w="1076201"/>
                <a:gridCol w="1368415"/>
                <a:gridCol w="377739"/>
                <a:gridCol w="570172"/>
              </a:tblGrid>
              <a:tr h="134084">
                <a:tc gridSpan="6"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 dirty="0" err="1">
                          <a:effectLst/>
                        </a:rPr>
                        <a:t>Uninfected</a:t>
                      </a:r>
                      <a:r>
                        <a:rPr lang="fr-FR" sz="800" u="none" strike="noStrike" dirty="0">
                          <a:effectLst/>
                        </a:rPr>
                        <a:t> &lt; </a:t>
                      </a:r>
                      <a:r>
                        <a:rPr lang="fr-FR" sz="800" u="none" strike="noStrike" dirty="0" err="1">
                          <a:effectLst/>
                        </a:rPr>
                        <a:t>Infected</a:t>
                      </a:r>
                      <a:endParaRPr lang="fr-FR" sz="800" b="1" i="0" u="none" strike="noStrike" dirty="0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  <a:tr h="134084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nnotation</a:t>
                      </a:r>
                      <a:endParaRPr lang="fr-FR" sz="800" b="1" i="0" u="none" strike="noStrike">
                        <a:solidFill>
                          <a:srgbClr val="FFFFFF"/>
                        </a:solidFill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ccession number</a:t>
                      </a:r>
                      <a:endParaRPr lang="fr-FR" sz="800" b="1" i="0" u="none" strike="noStrike">
                        <a:solidFill>
                          <a:srgbClr val="FFFFFF"/>
                        </a:solidFill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GO</a:t>
                      </a:r>
                      <a:endParaRPr lang="fr-FR" sz="800" b="1" i="0" u="none" strike="noStrike">
                        <a:solidFill>
                          <a:srgbClr val="FFFFFF"/>
                        </a:solidFill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Name and other names</a:t>
                      </a:r>
                      <a:endParaRPr lang="fr-FR" sz="800" b="1" i="0" u="none" strike="noStrike">
                        <a:solidFill>
                          <a:srgbClr val="FFFFFF"/>
                        </a:solidFill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R</a:t>
                      </a:r>
                      <a:endParaRPr lang="fr-FR" sz="800" b="1" i="0" u="none" strike="noStrike">
                        <a:solidFill>
                          <a:srgbClr val="FFFFFF"/>
                        </a:solidFill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Discussed</a:t>
                      </a:r>
                      <a:endParaRPr lang="fr-FR" sz="800" b="1" i="0" u="none" strike="noStrike">
                        <a:solidFill>
                          <a:srgbClr val="FFFFFF"/>
                        </a:solidFill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Baculoviral IAP repeat-containing protein 7 </a:t>
                      </a:r>
                      <a:endParaRPr lang="en-US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CU994887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u="none" strike="noStrike">
                          <a:effectLst/>
                        </a:rPr>
                        <a:t>apoptosis/cell cycle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birc7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56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x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Cell division cycle protein 20 homolog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M865357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Cdc20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38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x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40S ribosomal protein S23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CD526842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rowSpan="20">
                  <a:txBody>
                    <a:bodyPr/>
                    <a:lstStyle/>
                    <a:p>
                      <a:pPr algn="ctr" fontAlgn="ctr"/>
                      <a:r>
                        <a:rPr lang="fr-FR" sz="800" u="none" strike="noStrike">
                          <a:effectLst/>
                        </a:rPr>
                        <a:t>cell signalling/cell activation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RpS23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66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Calcium and integrin-binding protein 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CU986339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CIB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60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x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Coiled-coil domain-containing protein 43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BQ426328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Ccdc43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64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60S ribosomal protein L12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BQ427094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Rpl12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62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60S ribosomal protein L13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CF369193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rpl13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64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AB hydrolase superfamily protein C1039.03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FP003945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SPAC1039.03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65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Amyloid protein-binding protein 2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CU98673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Appbp2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57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Armadillo repeat-containing protein 7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CU992922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Armc7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6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Calexcitin-1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CU997857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cex-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63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Cytohesin-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CU999203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CYTH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67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DEP domain-containing protein 7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M868038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Depdc7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66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Polysialoglycoprotein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CU994256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PSPG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69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Rab9 effector protein with Kelch motifs</a:t>
                      </a:r>
                      <a:endParaRPr lang="en-US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CU999557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rabepk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62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Ras-related protein Rab-1A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CU987153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RAB1A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62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 dirty="0" err="1">
                          <a:effectLst/>
                        </a:rPr>
                        <a:t>Retinal-specific</a:t>
                      </a:r>
                      <a:r>
                        <a:rPr lang="fr-FR" sz="800" u="none" strike="noStrike" dirty="0">
                          <a:effectLst/>
                        </a:rPr>
                        <a:t> ATP-</a:t>
                      </a:r>
                      <a:r>
                        <a:rPr lang="fr-FR" sz="800" u="none" strike="noStrike" dirty="0" err="1">
                          <a:effectLst/>
                        </a:rPr>
                        <a:t>binding</a:t>
                      </a:r>
                      <a:r>
                        <a:rPr lang="fr-FR" sz="800" u="none" strike="noStrike" dirty="0">
                          <a:effectLst/>
                        </a:rPr>
                        <a:t> cassette transporter</a:t>
                      </a:r>
                      <a:endParaRPr lang="fr-FR" sz="800" b="0" i="0" u="none" strike="noStrike" dirty="0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CU684093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ABCA4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60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Sclerostin domain-containing protein 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M864487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Sostdc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68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Serine/threonine-protein kinase N2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CU984253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PKN2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62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Type-1 angiotensin II receptor-associated protein-like</a:t>
                      </a:r>
                      <a:endParaRPr lang="en-US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M854529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agtrap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6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Tyrosine-protein kinase HCK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FP00523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HCK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65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Vesicle transport protein GOT1B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CU991923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GOLT1B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58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Myosin-9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FP000092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rowSpan="7">
                  <a:txBody>
                    <a:bodyPr/>
                    <a:lstStyle/>
                    <a:p>
                      <a:pPr algn="ctr" fontAlgn="ctr"/>
                      <a:r>
                        <a:rPr lang="fr-FR" sz="800" u="none" strike="noStrike">
                          <a:effectLst/>
                        </a:rPr>
                        <a:t>Cell structure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Myosin-9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7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Actin, cytoskeletal 1B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CU686358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Actin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7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x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Collagen alpha-1(II) chain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CU683372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Collagen alpha-1(II)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69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Talin-2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FP010469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Talin-2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7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x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Tubulin alpha-3 chain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BQ426517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Tubulin alpha-3 chain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7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x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Tubulin beta chain (Fragment)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CX739463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Tubulin beta chain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70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x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Tubulin beta-2 chain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CD526843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Tubulin beta-2 chain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70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x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Leukocyte receptor cluster member 8 homolog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M859470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fr-FR" sz="800" u="none" strike="noStrike">
                          <a:effectLst/>
                        </a:rPr>
                        <a:t>immunity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leng8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73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x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Putative fungistatic metabolite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CX739389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CHGG_05463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72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CD109 antigen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M869309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CD109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73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x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Cytadherence high molecular weight protein 2</a:t>
                      </a:r>
                      <a:endParaRPr lang="en-US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J565545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hlp2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72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x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COMM domain-containing protein 3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CU986830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COMMD3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74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 3,2-trans-enoyl-CoA isomerase, mitochondrial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CU996326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fr-FR" sz="800" u="none" strike="noStrike">
                          <a:effectLst/>
                        </a:rPr>
                        <a:t>metabolism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Dci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76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Ceruloplasmin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BQ426238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Ceruloplasmin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76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Acyl-CoA-binding protein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CU995129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DBI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74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Flavin-containing monooxygenase FMO GS-OX4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M867598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FMOGS-OX4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76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WNK1_MOUSE Serine/threonine-protein kinase WNK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FP009560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Wnk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75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Cerebellin-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CU988765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fr-FR" sz="800" u="none" strike="noStrike">
                          <a:effectLst/>
                        </a:rPr>
                        <a:t>nervous system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Cerebellin-1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78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x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Protein tumorous imaginal discs, mitochondrial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M860387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l(2)tid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78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similar to reticulon 4 isoform B2</a:t>
                      </a:r>
                      <a:endParaRPr lang="en-US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M862946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reticulon 4 isoform B2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77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x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26S protease regulatory subunit 6B</a:t>
                      </a:r>
                      <a:endParaRPr lang="en-US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CU685038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fr-FR" sz="800" u="none" strike="noStrike">
                          <a:effectLst/>
                        </a:rPr>
                        <a:t>proteasome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PSMC4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79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CCR4-NOT transcription complex subunit 4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M862216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Cnot4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80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x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E3 ubiquitin-protein ligase RFWD2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FP012034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Rfwd2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80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Tripartite motif-containing protein 2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CU684964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Trim2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79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x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Centrosomal protein of 97 kDa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CU684766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rowSpan="9">
                  <a:txBody>
                    <a:bodyPr/>
                    <a:lstStyle/>
                    <a:p>
                      <a:pPr algn="ctr" fontAlgn="ctr"/>
                      <a:r>
                        <a:rPr lang="fr-FR" sz="800" u="none" strike="noStrike">
                          <a:effectLst/>
                        </a:rPr>
                        <a:t>Replication/transcription and DNA repair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cep97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82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F-box only protein 1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M863584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Fbxo1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85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Homeobox protein AKR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CU990086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Homeobox protein AKR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8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Krueppel-like factor 5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CU98954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Krueppel-like factor 5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85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ext to BRCA1 gene 1 protein</a:t>
                      </a:r>
                      <a:endParaRPr lang="en-US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FP000312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NBR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84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tRNA (uracil-5-)-methyltransferase homolog A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M868583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TRMT2A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84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YEATS domain-containing protein 4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FP011157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Yeats4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80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Zinc finger MYND domain-containing protein 1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FP008458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Zmynd1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87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Zinc finger protein 487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CU991188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ZNF487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82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34084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RNA1 polyprotein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FP010776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virus cycle of life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RNA1 polyprotein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0.94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 dirty="0">
                          <a:effectLst/>
                        </a:rPr>
                        <a:t>x</a:t>
                      </a:r>
                      <a:endParaRPr lang="fr-FR" sz="800" b="0" i="0" u="none" strike="noStrike" dirty="0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</a:tbl>
          </a:graphicData>
        </a:graphic>
      </p:graphicFrame>
      <p:sp>
        <p:nvSpPr>
          <p:cNvPr id="3" name="ZoneTexte 2"/>
          <p:cNvSpPr txBox="1"/>
          <p:nvPr/>
        </p:nvSpPr>
        <p:spPr>
          <a:xfrm>
            <a:off x="206524" y="8332127"/>
            <a:ext cx="7200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120881768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19</TotalTime>
  <Words>451</Words>
  <Application>Microsoft Office PowerPoint</Application>
  <PresentationFormat>Personnalisé</PresentationFormat>
  <Paragraphs>296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RH</dc:creator>
  <cp:lastModifiedBy>Aude</cp:lastModifiedBy>
  <cp:revision>87</cp:revision>
  <cp:lastPrinted>2012-10-25T11:27:23Z</cp:lastPrinted>
  <dcterms:created xsi:type="dcterms:W3CDTF">2012-10-16T07:53:20Z</dcterms:created>
  <dcterms:modified xsi:type="dcterms:W3CDTF">2013-02-28T13:52:54Z</dcterms:modified>
</cp:coreProperties>
</file>